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84762" autoAdjust="0"/>
  </p:normalViewPr>
  <p:slideViewPr>
    <p:cSldViewPr snapToGrid="0">
      <p:cViewPr varScale="1">
        <p:scale>
          <a:sx n="85" d="100"/>
          <a:sy n="85" d="100"/>
        </p:scale>
        <p:origin x="4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B65406-17DC-458F-BDE8-5AA759AC3E77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40BF82-9B37-4D96-A69B-06BCFDFF7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2471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40BF82-9B37-4D96-A69B-06BCFDFF7A8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977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AC5BF2-9713-4BDA-BB53-6D2D80F895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5C5BD4-5336-44B0-90D1-7B39A15050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96FD1-631C-4FEB-9A7F-A5516577A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9B422-F819-4708-9926-7F5F0FE69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163C1F-D397-4702-9A24-AE42A33AA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282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D698E-E6E4-4877-937C-4840EE9CF0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6A0823-5437-4E39-B04A-DF5CB80EC2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83B87-ACDA-4E93-B00D-0BCA3A30D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34226F-2A34-443D-84BE-2E65B23BF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4C2C20-944A-4FD7-80CE-986C893FC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3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0FABC8-C7D8-4E4B-9ED0-186DD8E604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53E445-05D7-4BD8-BDA4-FECD5C815B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8828C5-40A6-4F15-8B42-CBCDED6A7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882745-8AD1-483E-81C6-6CDA0D873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A7AB2D-98EB-4039-8186-9FC2B6C3B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85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83E87B-8562-4C2D-976D-6E269472A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CB4263-E87F-49E1-91C8-E1834A73E2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8186F1-682A-4056-91AD-DCA8E5106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1E30C5-95DE-410E-96AC-572D3E80B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05F2BB-514E-4E93-A247-CE0FADFC0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696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ADE957-7BE1-4CBA-9894-CF8EAE7CF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C1CB4-EC56-49D1-9A2F-4ED6D2D65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143F63-DAE3-40CA-BB95-D1D9BF2F5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ACCF3C-DE33-4B11-8825-1300CFF28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692C2-2087-4095-BEBF-86E4FD8EB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321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366CF-D583-4C11-B2BC-2E63B75E0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1CD56B-037E-4459-8378-202D2740E5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D9A684-193E-4550-9371-50E7BDA903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FC048D-9141-4C91-BC46-204C666F5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9DC61D-7BBC-45F7-8F3B-E8066C130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9CD26E-89DE-484A-A88A-39710FA3B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29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F585E-88F0-4CF1-9EFB-A8AFA3561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EB713F-FC91-40F2-A81C-6FEB295DD8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45784C-73A2-4157-AC44-E3A2E8344F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94456E-90D8-4637-9BC4-EC48CC390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BF097D-727A-4307-B8F0-BE0D321C4A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D23CDC-E1A2-4BA8-8C29-552C1B37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D67DEA-F39A-48D2-A81A-2634641A7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02D492-68E1-45EE-AFA8-6D6D60AF2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926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0BD00-E3F2-4FC0-95BD-AEADB1666D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C37B9E-B751-48E7-A36E-8FBB21261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BD9C87-A671-496A-8DFA-B9B5C9C3C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2A607A-DD21-4D17-9998-78AB7C3D3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790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816768-BFE9-4F5E-BCD5-5F9339B70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538044-860A-4EA3-8467-627FA6430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C80301-83A9-4FD4-8295-A2DB29D14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718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23606-2342-4DF1-A302-1CE0522F7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FB8326-D77F-478D-999C-1E32F9C425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1C2278-7B77-4D2A-8199-AEA6CE0F2E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B35B84-F75E-417B-892A-76C23539F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82BCF4-B7DE-4D8A-B3F5-3EB8434A7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EB8522-829A-4DDC-9423-AA8DBEBDD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279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39F2E5-25B8-4084-838E-78A29CCDB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D16CC7-DFC3-495E-A365-07D4413C76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91EC55-5E08-4AA6-952B-575A7951AA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850391-8E52-4A31-B03A-319B33EEB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4748F6-AC77-4A1E-841B-5C2586817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8970E9-069B-409B-85A8-BDF876BD9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370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BB5D0A-EC82-426A-8E01-302F32553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3B50A2-5A29-4C59-B1A2-DC5B36909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4DAB54-22D8-4FD1-8705-C99305D3BF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09CE89-8D41-43FB-8402-821365136F0A}" type="datetimeFigureOut">
              <a:rPr lang="en-US" smtClean="0"/>
              <a:t>4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CD245F-D01D-43B5-A500-D8C2C4306A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E8CB6A-006E-4DA1-8EE6-1152A54803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04F23-A886-4F8B-B7CB-193F16412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25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04B0455-7B22-4AE9-BC70-498BBC9028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2450074"/>
              </p:ext>
            </p:extLst>
          </p:nvPr>
        </p:nvGraphicFramePr>
        <p:xfrm>
          <a:off x="328483" y="807472"/>
          <a:ext cx="11599354" cy="4309332"/>
        </p:xfrm>
        <a:graphic>
          <a:graphicData uri="http://schemas.openxmlformats.org/drawingml/2006/table">
            <a:tbl>
              <a:tblPr firstRow="1" firstCol="1" bandRow="1"/>
              <a:tblGrid>
                <a:gridCol w="1488895">
                  <a:extLst>
                    <a:ext uri="{9D8B030D-6E8A-4147-A177-3AD203B41FA5}">
                      <a16:colId xmlns:a16="http://schemas.microsoft.com/office/drawing/2014/main" val="3787906543"/>
                    </a:ext>
                  </a:extLst>
                </a:gridCol>
                <a:gridCol w="1007333">
                  <a:extLst>
                    <a:ext uri="{9D8B030D-6E8A-4147-A177-3AD203B41FA5}">
                      <a16:colId xmlns:a16="http://schemas.microsoft.com/office/drawing/2014/main" val="1664301351"/>
                    </a:ext>
                  </a:extLst>
                </a:gridCol>
                <a:gridCol w="952919">
                  <a:extLst>
                    <a:ext uri="{9D8B030D-6E8A-4147-A177-3AD203B41FA5}">
                      <a16:colId xmlns:a16="http://schemas.microsoft.com/office/drawing/2014/main" val="2314098674"/>
                    </a:ext>
                  </a:extLst>
                </a:gridCol>
                <a:gridCol w="1033412">
                  <a:extLst>
                    <a:ext uri="{9D8B030D-6E8A-4147-A177-3AD203B41FA5}">
                      <a16:colId xmlns:a16="http://schemas.microsoft.com/office/drawing/2014/main" val="31595888"/>
                    </a:ext>
                  </a:extLst>
                </a:gridCol>
                <a:gridCol w="1029075">
                  <a:extLst>
                    <a:ext uri="{9D8B030D-6E8A-4147-A177-3AD203B41FA5}">
                      <a16:colId xmlns:a16="http://schemas.microsoft.com/office/drawing/2014/main" val="221583262"/>
                    </a:ext>
                  </a:extLst>
                </a:gridCol>
                <a:gridCol w="1033409">
                  <a:extLst>
                    <a:ext uri="{9D8B030D-6E8A-4147-A177-3AD203B41FA5}">
                      <a16:colId xmlns:a16="http://schemas.microsoft.com/office/drawing/2014/main" val="836761352"/>
                    </a:ext>
                  </a:extLst>
                </a:gridCol>
                <a:gridCol w="931205">
                  <a:extLst>
                    <a:ext uri="{9D8B030D-6E8A-4147-A177-3AD203B41FA5}">
                      <a16:colId xmlns:a16="http://schemas.microsoft.com/office/drawing/2014/main" val="1589535599"/>
                    </a:ext>
                  </a:extLst>
                </a:gridCol>
                <a:gridCol w="1044765">
                  <a:extLst>
                    <a:ext uri="{9D8B030D-6E8A-4147-A177-3AD203B41FA5}">
                      <a16:colId xmlns:a16="http://schemas.microsoft.com/office/drawing/2014/main" val="4242456583"/>
                    </a:ext>
                  </a:extLst>
                </a:gridCol>
                <a:gridCol w="976628">
                  <a:extLst>
                    <a:ext uri="{9D8B030D-6E8A-4147-A177-3AD203B41FA5}">
                      <a16:colId xmlns:a16="http://schemas.microsoft.com/office/drawing/2014/main" val="2197906560"/>
                    </a:ext>
                  </a:extLst>
                </a:gridCol>
                <a:gridCol w="1010697">
                  <a:extLst>
                    <a:ext uri="{9D8B030D-6E8A-4147-A177-3AD203B41FA5}">
                      <a16:colId xmlns:a16="http://schemas.microsoft.com/office/drawing/2014/main" val="3242375043"/>
                    </a:ext>
                  </a:extLst>
                </a:gridCol>
                <a:gridCol w="1091016">
                  <a:extLst>
                    <a:ext uri="{9D8B030D-6E8A-4147-A177-3AD203B41FA5}">
                      <a16:colId xmlns:a16="http://schemas.microsoft.com/office/drawing/2014/main" val="739419824"/>
                    </a:ext>
                  </a:extLst>
                </a:gridCol>
              </a:tblGrid>
              <a:tr h="148707">
                <a:tc>
                  <a:txBody>
                    <a:bodyPr/>
                    <a:lstStyle/>
                    <a:p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oplastic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lammatory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nal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ectious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diopathic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342325"/>
                  </a:ext>
                </a:extLst>
              </a:tr>
              <a:tr h="5246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16,342 (36.6%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5,639 (12.6%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4,036 (9.04%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3,418 (7.66%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15,202 (34.1%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077027"/>
                  </a:ext>
                </a:extLst>
              </a:tr>
              <a:tr h="370342">
                <a:tc>
                  <a:txBody>
                    <a:bodyPr/>
                    <a:lstStyle/>
                    <a:p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OR or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coefficient*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OR or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coefficient*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OR or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coefficient*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OR or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oefficient*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OR or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coefficient*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50096051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-hospital mortality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7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00, 1.38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7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08, 1.76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1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09, 2.08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94, 1.37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29, 2.04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8044104"/>
                  </a:ext>
                </a:extLst>
              </a:tr>
              <a:tr h="148707">
                <a:tc>
                  <a:txBody>
                    <a:bodyPr/>
                    <a:lstStyle/>
                    <a:p>
                      <a:endParaRPr lang="en-US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6538382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intervention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.3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4.1, 29.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9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8.04, 23.9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85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4.83, 20.1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7.78, 18.3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6.70, 17.1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69560443"/>
                  </a:ext>
                </a:extLst>
              </a:tr>
              <a:tr h="148707">
                <a:tc>
                  <a:txBody>
                    <a:bodyPr/>
                    <a:lstStyle/>
                    <a:p>
                      <a:endParaRPr lang="en-US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4963603"/>
                  </a:ext>
                </a:extLst>
              </a:tr>
              <a:tr h="16900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lications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3294972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Cardiac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6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23, 1.98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92, 1.6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9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38, 2.7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20, 1.89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24, 1.87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89128721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Infectious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06, 0.6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03, 0.9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3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20, 10.1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06, 0.37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03, 1.33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39791198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Respiratory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30, 0.50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21, 0.46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18, 0.64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23, 0.44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21, 0.39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458625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Blood transfusion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62, 0.85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55, 0.84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83, 1.33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60, 0.87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68, 0.97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8544278"/>
                  </a:ext>
                </a:extLst>
              </a:tr>
              <a:tr h="148707">
                <a:tc>
                  <a:txBody>
                    <a:bodyPr/>
                    <a:lstStyle/>
                    <a:p>
                      <a:endParaRPr lang="en-US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6680736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-Day readmission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2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91, 1.14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88, 1.2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.01, 1.61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91, 1.25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0.93, 1.23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212561"/>
                  </a:ext>
                </a:extLst>
              </a:tr>
              <a:tr h="148707">
                <a:tc>
                  <a:txBody>
                    <a:bodyPr/>
                    <a:lstStyle/>
                    <a:p>
                      <a:endParaRPr lang="en-US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7059654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dex hospitalization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9833039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LOS (days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97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.30, -0.65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.28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.71, -0.85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.46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2.57, -0.36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2.2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3.01, -1.43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.1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.40, -0.92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6913020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Cost ($1,000) 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2.25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3.55, -0.96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3.5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5.30, -1.78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2.86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6.80, 1.07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0.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3.9, -6.18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4.1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5.40, -2.93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68462878"/>
                  </a:ext>
                </a:extLst>
              </a:tr>
              <a:tr h="148707">
                <a:tc>
                  <a:txBody>
                    <a:bodyPr/>
                    <a:lstStyle/>
                    <a:p>
                      <a:endParaRPr lang="en-US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26575900"/>
                  </a:ext>
                </a:extLst>
              </a:tr>
              <a:tr h="16900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-Day cumulative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46157050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LOS (days) 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68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.96, 0.61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2.18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4.08, -0.29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2.15, 4.83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.4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3.55, 0.70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5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.88, 0.72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93632765"/>
                  </a:ext>
                </a:extLst>
              </a:tr>
              <a:tr h="2112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Cost ($1,000)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6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2.82, 8.13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2.45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1.7, 6.82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5.94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7.5, 5.59]</a:t>
                      </a:r>
                    </a:p>
                  </a:txBody>
                  <a:tcPr marL="65210" marR="6521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8.2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19.9, 3.29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-4.47, 7.18]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6389675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5EC090D-A548-4583-B4D3-8178D68A0973}"/>
              </a:ext>
            </a:extLst>
          </p:cNvPr>
          <p:cNvSpPr txBox="1"/>
          <p:nvPr/>
        </p:nvSpPr>
        <p:spPr>
          <a:xfrm rot="10800000" flipV="1">
            <a:off x="278237" y="5270042"/>
            <a:ext cx="112516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breviations: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O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djusted odds ratio;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95% C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95% confidence interval;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LO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length of stay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Adjusted outcomes are reported as adjusted odds ratios or </a:t>
            </a:r>
            <a:r>
              <a:rPr lang="el-GR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oefficients. Surgical drainage as reference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B28A0A-09D4-4CA9-83D6-B268B4919A92}"/>
              </a:ext>
            </a:extLst>
          </p:cNvPr>
          <p:cNvSpPr txBox="1"/>
          <p:nvPr/>
        </p:nvSpPr>
        <p:spPr>
          <a:xfrm rot="10800000" flipV="1">
            <a:off x="290594" y="416683"/>
            <a:ext cx="112516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4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djusted outcomes stratified by etiology of pericardial effusion (Reference: Surgical drainage)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84EF97B-68BA-3346-BC0F-2C5585C2C54C}"/>
              </a:ext>
            </a:extLst>
          </p:cNvPr>
          <p:cNvCxnSpPr>
            <a:cxnSpLocks/>
          </p:cNvCxnSpPr>
          <p:nvPr/>
        </p:nvCxnSpPr>
        <p:spPr>
          <a:xfrm>
            <a:off x="315308" y="5195480"/>
            <a:ext cx="1159935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9872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</TotalTime>
  <Words>565</Words>
  <Application>Microsoft Office PowerPoint</Application>
  <PresentationFormat>Widescreen</PresentationFormat>
  <Paragraphs>18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Chelsea (Medical Student)</dc:creator>
  <cp:lastModifiedBy>Pan, Chelsea (Medical Student)</cp:lastModifiedBy>
  <cp:revision>31</cp:revision>
  <dcterms:created xsi:type="dcterms:W3CDTF">2022-03-27T18:50:51Z</dcterms:created>
  <dcterms:modified xsi:type="dcterms:W3CDTF">2022-04-11T01:14:39Z</dcterms:modified>
</cp:coreProperties>
</file>